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1">
          <p15:clr>
            <a:srgbClr val="A4A3A4"/>
          </p15:clr>
        </p15:guide>
        <p15:guide id="2" pos="298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napToObjects="1" showGuides="1">
      <p:cViewPr>
        <p:scale>
          <a:sx n="164" d="100"/>
          <a:sy n="164" d="100"/>
        </p:scale>
        <p:origin x="-1576" y="136"/>
      </p:cViewPr>
      <p:guideLst>
        <p:guide orient="horz" pos="2171"/>
        <p:guide pos="298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51E2D-06B3-A14A-BADF-1A9EA4A59415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4694A4-5CF1-944E-A3E9-6890100CEA5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328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4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74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09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97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334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8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771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755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40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2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708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48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99757"/>
              </p:ext>
            </p:extLst>
          </p:nvPr>
        </p:nvGraphicFramePr>
        <p:xfrm>
          <a:off x="1939159" y="198753"/>
          <a:ext cx="4771730" cy="6628071"/>
        </p:xfrm>
        <a:graphic>
          <a:graphicData uri="http://schemas.openxmlformats.org/drawingml/2006/table">
            <a:tbl>
              <a:tblPr/>
              <a:tblGrid>
                <a:gridCol w="16281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2392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2392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239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2392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2392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2392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de-DE" sz="6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COVID-19 IMPACT  FROM 2022 TO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%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Survived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  %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Dead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 %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CU admission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isease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M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.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8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2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.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HL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.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LC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D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ast therapy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rget therapy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.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4.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.8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mmuno-chemotherapy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3.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.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.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5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emotherapy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vid-19 infections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itical illness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symptomatic illness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.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vere illness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.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6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ld illness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.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1.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.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.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.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8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derate illness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2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7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anuary-June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.3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7"/>
                  </a:ext>
                </a:extLst>
              </a:tr>
              <a:tr h="92199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July-December 2023</a:t>
                      </a:r>
                    </a:p>
                  </a:txBody>
                  <a:tcPr marL="4619" marR="4619" marT="4619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4619" marR="4619" marT="4619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8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-70947" y="-51279"/>
            <a:ext cx="43727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Table 6.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VID-19 impact from 2022 to 2023</a:t>
            </a:r>
          </a:p>
        </p:txBody>
      </p:sp>
    </p:spTree>
    <p:extLst>
      <p:ext uri="{BB962C8B-B14F-4D97-AF65-F5344CB8AC3E}">
        <p14:creationId xmlns:p14="http://schemas.microsoft.com/office/powerpoint/2010/main" val="3706672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7</Words>
  <Application>Microsoft Office PowerPoint</Application>
  <PresentationFormat>Presentazione su schermo (4:3)</PresentationFormat>
  <Paragraphs>38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e</dc:creator>
  <cp:lastModifiedBy>Daniele Caracciolo</cp:lastModifiedBy>
  <cp:revision>102</cp:revision>
  <dcterms:created xsi:type="dcterms:W3CDTF">2024-10-12T13:22:48Z</dcterms:created>
  <dcterms:modified xsi:type="dcterms:W3CDTF">2025-05-25T20:02:51Z</dcterms:modified>
</cp:coreProperties>
</file>